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4" r:id="rId2"/>
    <p:sldId id="256" r:id="rId3"/>
  </p:sldIdLst>
  <p:sldSz cx="12192000" cy="68580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FCF56373-9CDF-438C-8144-FA10D618BE1D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3638"/>
            <a:ext cx="558165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6"/>
            <a:ext cx="5615940" cy="3664208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490FEB2C-719D-43DF-9945-32C9E59B13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2555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CA693A-66EF-4B17-A7B6-95C6EAFDA78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9528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62065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6618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0025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7166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00781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6038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951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0819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66841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64579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3636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543D7-54D0-4C4E-91C6-C01F5BCCB48A}" type="datetimeFigureOut">
              <a:rPr lang="en-CA" smtClean="0"/>
              <a:t>2023-03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007ED-00CA-4148-9ECD-ECE1C7321D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1246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3" name="Conector recto 11"/>
          <p:cNvCxnSpPr/>
          <p:nvPr/>
        </p:nvCxnSpPr>
        <p:spPr>
          <a:xfrm flipV="1">
            <a:off x="396090" y="1215556"/>
            <a:ext cx="6597241" cy="12781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V="1">
            <a:off x="390429" y="1080296"/>
            <a:ext cx="0" cy="304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V="1">
            <a:off x="2705004" y="1080296"/>
            <a:ext cx="0" cy="304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flipV="1">
            <a:off x="5038629" y="1080296"/>
            <a:ext cx="0" cy="304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Isosceles Triangle 59"/>
          <p:cNvSpPr/>
          <p:nvPr/>
        </p:nvSpPr>
        <p:spPr>
          <a:xfrm rot="10800000">
            <a:off x="4242518" y="1020974"/>
            <a:ext cx="116993" cy="1333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cxnSp>
        <p:nvCxnSpPr>
          <p:cNvPr id="61" name="Straight Connector 60"/>
          <p:cNvCxnSpPr/>
          <p:nvPr/>
        </p:nvCxnSpPr>
        <p:spPr>
          <a:xfrm flipV="1">
            <a:off x="5391054" y="1070771"/>
            <a:ext cx="0" cy="304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V="1">
            <a:off x="7000779" y="1089821"/>
            <a:ext cx="0" cy="304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-323047" y="1314705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Prime </a:t>
            </a:r>
          </a:p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vaccination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827493" y="1201888"/>
            <a:ext cx="1400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28 days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2004559" y="1306447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Boost </a:t>
            </a:r>
          </a:p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vaccination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244885" y="1200978"/>
            <a:ext cx="1400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28 days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530153" y="1628876"/>
            <a:ext cx="1400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3 days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3608711" y="552923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Day 49 </a:t>
            </a:r>
          </a:p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bleed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4301014" y="631302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Virus </a:t>
            </a:r>
          </a:p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challenge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704324" y="1297437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Necropsy</a:t>
            </a:r>
          </a:p>
          <a:p>
            <a:pPr algn="ctr"/>
            <a:endParaRPr lang="en-CA" sz="1200" b="1" dirty="0">
              <a:cs typeface="Times New Roman" panose="02020603050405020304" pitchFamily="18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5015123" y="1603954"/>
            <a:ext cx="397396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 flipV="1">
            <a:off x="5008886" y="1928417"/>
            <a:ext cx="1991893" cy="563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5442511" y="1934048"/>
            <a:ext cx="1400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14 days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6326790" y="1324523"/>
            <a:ext cx="140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cs typeface="Times New Roman" panose="02020603050405020304" pitchFamily="18" charset="0"/>
              </a:rPr>
              <a:t>Necropsy</a:t>
            </a:r>
          </a:p>
          <a:p>
            <a:pPr algn="ctr"/>
            <a:endParaRPr lang="en-CA" sz="1200" b="1" dirty="0"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883843" y="2095404"/>
            <a:ext cx="2408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cs typeface="Times New Roman" panose="02020603050405020304" pitchFamily="18" charset="0"/>
              </a:rPr>
              <a:t>Monitor weight loss and survival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731825" y="304784"/>
            <a:ext cx="39257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cs typeface="Times New Roman" panose="02020603050405020304" pitchFamily="18" charset="0"/>
              </a:rPr>
              <a:t>Influenza Animal Study timeline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31418" y="-25167"/>
            <a:ext cx="2076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highlight>
                  <a:srgbClr val="FFFF00"/>
                </a:highlight>
                <a:cs typeface="Times New Roman" panose="02020603050405020304" pitchFamily="18" charset="0"/>
              </a:rPr>
              <a:t>Figure S1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98524" y="245146"/>
            <a:ext cx="419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331714" y="145749"/>
            <a:ext cx="419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233485" y="832851"/>
            <a:ext cx="14432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cs typeface="Times New Roman" panose="02020603050405020304" pitchFamily="18" charset="0"/>
              </a:rPr>
              <a:t>(500 PFU)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5493631"/>
              </p:ext>
            </p:extLst>
          </p:nvPr>
        </p:nvGraphicFramePr>
        <p:xfrm>
          <a:off x="7573026" y="476508"/>
          <a:ext cx="4795711" cy="2412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5328568" imgH="2680266" progId="">
                  <p:embed/>
                </p:oleObj>
              </mc:Choice>
              <mc:Fallback>
                <p:oleObj r:id="rId3" imgW="5328568" imgH="2680266" progId="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73026" y="476508"/>
                        <a:ext cx="4795711" cy="24122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F357921-8F3F-E7F6-5D97-DC8B45F25A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6692491"/>
              </p:ext>
            </p:extLst>
          </p:nvPr>
        </p:nvGraphicFramePr>
        <p:xfrm>
          <a:off x="404438" y="2790313"/>
          <a:ext cx="4359414" cy="29988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5891100" imgH="4052453" progId="">
                  <p:embed/>
                </p:oleObj>
              </mc:Choice>
              <mc:Fallback>
                <p:oleObj r:id="rId5" imgW="5891100" imgH="4052453" progId="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4438" y="2790313"/>
                        <a:ext cx="4359414" cy="29988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1401BDC-F60D-60C1-CA73-36C5F5B3A1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3676046"/>
              </p:ext>
            </p:extLst>
          </p:nvPr>
        </p:nvGraphicFramePr>
        <p:xfrm>
          <a:off x="5570771" y="3211732"/>
          <a:ext cx="2787610" cy="2716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3767040" imgH="3671280" progId="">
                  <p:embed/>
                </p:oleObj>
              </mc:Choice>
              <mc:Fallback>
                <p:oleObj r:id="rId7" imgW="3767040" imgH="3671280" progId="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70771" y="3211732"/>
                        <a:ext cx="2787610" cy="2716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129BE1D-E03C-065F-3412-FC2A5CBC56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3363301"/>
              </p:ext>
            </p:extLst>
          </p:nvPr>
        </p:nvGraphicFramePr>
        <p:xfrm>
          <a:off x="8332899" y="2865180"/>
          <a:ext cx="2788927" cy="3056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3768820" imgH="4130247" progId="">
                  <p:embed/>
                </p:oleObj>
              </mc:Choice>
              <mc:Fallback>
                <p:oleObj r:id="rId9" imgW="3768820" imgH="4130247" progId="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332899" y="2865180"/>
                        <a:ext cx="2788927" cy="3056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1378922-6858-19DC-1CE2-DF37E13501AB}"/>
              </a:ext>
            </a:extLst>
          </p:cNvPr>
          <p:cNvSpPr txBox="1"/>
          <p:nvPr/>
        </p:nvSpPr>
        <p:spPr>
          <a:xfrm>
            <a:off x="194472" y="2539763"/>
            <a:ext cx="419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420C7D-94D5-583F-C739-7DD10F143D94}"/>
              </a:ext>
            </a:extLst>
          </p:cNvPr>
          <p:cNvSpPr txBox="1"/>
          <p:nvPr/>
        </p:nvSpPr>
        <p:spPr>
          <a:xfrm>
            <a:off x="5453681" y="2639588"/>
            <a:ext cx="419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d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683AC07-D796-7099-A5BC-6C52BF99EA92}"/>
              </a:ext>
            </a:extLst>
          </p:cNvPr>
          <p:cNvSpPr txBox="1"/>
          <p:nvPr/>
        </p:nvSpPr>
        <p:spPr>
          <a:xfrm>
            <a:off x="101600" y="5926816"/>
            <a:ext cx="118668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/>
              <a:t>Figure S1</a:t>
            </a:r>
            <a:r>
              <a:rPr lang="en-CA" sz="1200" dirty="0"/>
              <a:t>. BALB/c mice were vaccinated intranasally in a prime/boost regimen, 4-weeks apart, with </a:t>
            </a:r>
            <a:r>
              <a:rPr lang="en-CA" sz="1200" dirty="0" err="1"/>
              <a:t>rAd</a:t>
            </a:r>
            <a:r>
              <a:rPr lang="en-CA" sz="1200" dirty="0"/>
              <a:t> vaccines and challenged intranasally with 500 PFU of influenza A at 4 weeks post boost. a) Schematic diagram of the immunization, influenza A challenge and necropsy timeline at a challenge dose of 500 PFU/mouse is shown. b) Survival (n=6) is shown. Median survival time since day of challenge – Ad-empty: 7 days, all vaccinated groups:  &gt; 14 days. c) Weight loss data is shown. Data shown is </a:t>
            </a:r>
            <a:r>
              <a:rPr lang="en-CA" sz="1200" dirty="0" err="1"/>
              <a:t>mean±SEM</a:t>
            </a:r>
            <a:r>
              <a:rPr lang="en-CA" sz="1200" dirty="0"/>
              <a:t>. d) Virus titre from infected lungs and nose collected at 3 days post-challenge. The dotted line denotes the limit of detection (LOD) of the assay. </a:t>
            </a:r>
          </a:p>
        </p:txBody>
      </p:sp>
    </p:spTree>
    <p:extLst>
      <p:ext uri="{BB962C8B-B14F-4D97-AF65-F5344CB8AC3E}">
        <p14:creationId xmlns:p14="http://schemas.microsoft.com/office/powerpoint/2010/main" val="2139821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076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highlight>
                  <a:srgbClr val="FFFF00"/>
                </a:highlight>
                <a:cs typeface="Times New Roman" panose="02020603050405020304" pitchFamily="18" charset="0"/>
              </a:rPr>
              <a:t>Figure S2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9787438"/>
              </p:ext>
            </p:extLst>
          </p:nvPr>
        </p:nvGraphicFramePr>
        <p:xfrm>
          <a:off x="407656" y="307777"/>
          <a:ext cx="5157238" cy="30244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6969240" imgH="4087080" progId="">
                  <p:embed/>
                </p:oleObj>
              </mc:Choice>
              <mc:Fallback>
                <p:oleObj r:id="rId2" imgW="6969240" imgH="4087080" progId="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7656" y="307777"/>
                        <a:ext cx="5157238" cy="30244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F290F9C5-4BEB-25DF-4E8A-616106A1D196}"/>
              </a:ext>
            </a:extLst>
          </p:cNvPr>
          <p:cNvSpPr txBox="1"/>
          <p:nvPr/>
        </p:nvSpPr>
        <p:spPr>
          <a:xfrm>
            <a:off x="101600" y="3429000"/>
            <a:ext cx="11866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/>
              <a:t>Figure S2</a:t>
            </a:r>
            <a:r>
              <a:rPr lang="en-CA" sz="1200" dirty="0"/>
              <a:t>. BALB/c mice were vaccinated intranasally in a prime/boost regimen, 4-weeks apart, with </a:t>
            </a:r>
            <a:r>
              <a:rPr lang="en-CA" sz="1200" dirty="0" err="1"/>
              <a:t>rAd</a:t>
            </a:r>
            <a:r>
              <a:rPr lang="en-CA" sz="1200" dirty="0"/>
              <a:t> vaccines and challenged intranasally with 3×10</a:t>
            </a:r>
            <a:r>
              <a:rPr lang="en-CA" sz="1200" baseline="30000" dirty="0"/>
              <a:t>6 </a:t>
            </a:r>
            <a:r>
              <a:rPr lang="en-CA" sz="1200" dirty="0"/>
              <a:t>PFU of RSV-A2. Weight loss data is shown.</a:t>
            </a:r>
          </a:p>
        </p:txBody>
      </p:sp>
    </p:spTree>
    <p:extLst>
      <p:ext uri="{BB962C8B-B14F-4D97-AF65-F5344CB8AC3E}">
        <p14:creationId xmlns:p14="http://schemas.microsoft.com/office/powerpoint/2010/main" val="2059398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224</Words>
  <Application>Microsoft Office PowerPoint</Application>
  <PresentationFormat>Widescreen</PresentationFormat>
  <Paragraphs>26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Health Canada - Santé Cana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an, Sathya (HC/SC)</dc:creator>
  <cp:lastModifiedBy>Raman, Sathya (HC/SC)</cp:lastModifiedBy>
  <cp:revision>12</cp:revision>
  <cp:lastPrinted>2023-03-08T19:54:29Z</cp:lastPrinted>
  <dcterms:created xsi:type="dcterms:W3CDTF">2022-10-26T18:46:10Z</dcterms:created>
  <dcterms:modified xsi:type="dcterms:W3CDTF">2023-03-09T01:39:54Z</dcterms:modified>
</cp:coreProperties>
</file>